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97" r:id="rId2"/>
  </p:sldIdLst>
  <p:sldSz cx="15562263" cy="17546638"/>
  <p:notesSz cx="6858000" cy="9144000"/>
  <p:defaultTextStyle>
    <a:defPPr>
      <a:defRPr lang="en-US"/>
    </a:defPPr>
    <a:lvl1pPr marL="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0000"/>
    <a:srgbClr val="FFFFFF"/>
    <a:srgbClr val="FF40FF"/>
    <a:srgbClr val="AC27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9"/>
    <p:restoredTop sz="83745"/>
  </p:normalViewPr>
  <p:slideViewPr>
    <p:cSldViewPr snapToGrid="0">
      <p:cViewPr varScale="1">
        <p:scale>
          <a:sx n="59" d="100"/>
          <a:sy n="59" d="100"/>
        </p:scale>
        <p:origin x="283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B1137E9-3125-C9DC-069E-2EFC7FD4E75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E7326-5A68-8CF5-B93F-4FAFF79AC1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62AE7-0510-7043-8514-23341998D747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3C3C2B-31C4-A7B8-7F9A-4B2F8EF1A3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B5F93-70EB-5C72-5813-7DFAB1A2F89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5B7DB3-4B09-6441-9E1D-2E54A81E2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559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25ECA-95A8-D54D-A55C-966C5ABDC60E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143000"/>
            <a:ext cx="2736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02569-D9CA-7442-9875-62C29A14A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1143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202569-D9CA-7442-9875-62C29A14AB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9547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39EB-7257-7444-846C-A830F519A4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5286" y="2871639"/>
            <a:ext cx="11671697" cy="6108831"/>
          </a:xfrm>
        </p:spPr>
        <p:txBody>
          <a:bodyPr anchor="b">
            <a:normAutofit/>
          </a:bodyPr>
          <a:lstStyle>
            <a:lvl1pPr algn="ctr">
              <a:defRPr sz="4679"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FF011D-5936-024D-894E-5D7272C0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45286" y="9216051"/>
            <a:ext cx="11671697" cy="4236375"/>
          </a:xfrm>
        </p:spPr>
        <p:txBody>
          <a:bodyPr/>
          <a:lstStyle>
            <a:lvl1pPr marL="0" indent="0" algn="ctr">
              <a:buNone/>
              <a:defRPr sz="2808">
                <a:latin typeface="Helvetica" pitchFamily="2" charset="0"/>
                <a:cs typeface="Arial" panose="020B0604020202020204" pitchFamily="34" charset="0"/>
              </a:defRPr>
            </a:lvl1pPr>
            <a:lvl2pPr marL="534800" indent="0" algn="ctr">
              <a:buNone/>
              <a:defRPr sz="2339"/>
            </a:lvl2pPr>
            <a:lvl3pPr marL="1069601" indent="0" algn="ctr">
              <a:buNone/>
              <a:defRPr sz="2105"/>
            </a:lvl3pPr>
            <a:lvl4pPr marL="1604400" indent="0" algn="ctr">
              <a:buNone/>
              <a:defRPr sz="1871"/>
            </a:lvl4pPr>
            <a:lvl5pPr marL="2139200" indent="0" algn="ctr">
              <a:buNone/>
              <a:defRPr sz="1871"/>
            </a:lvl5pPr>
            <a:lvl6pPr marL="2674001" indent="0" algn="ctr">
              <a:buNone/>
              <a:defRPr sz="1871"/>
            </a:lvl6pPr>
            <a:lvl7pPr marL="3208801" indent="0" algn="ctr">
              <a:buNone/>
              <a:defRPr sz="1871"/>
            </a:lvl7pPr>
            <a:lvl8pPr marL="3743601" indent="0" algn="ctr">
              <a:buNone/>
              <a:defRPr sz="1871"/>
            </a:lvl8pPr>
            <a:lvl9pPr marL="4278401" indent="0" algn="ctr">
              <a:buNone/>
              <a:defRPr sz="187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4D72-5071-ED4A-AF12-75657B75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1C9DEA9D-5532-1949-9D14-26A30D988B6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47D9-31F9-BC40-AB2B-EC56AF8F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870F0-923B-0543-854F-D39BA676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1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044D-B51F-4546-8184-768D6ADE8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F9904-7979-7F43-95DE-C5378709E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F89EC-86B5-C74C-AABB-DC262193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1DBA4-200E-9843-B255-CEC4C6AAC196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63029-53B8-844B-B239-06CD1560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18CD-F8BD-C44A-8597-C2DB47E4D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21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8C94FF-AADF-BF41-A28C-B3390397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136743" y="934196"/>
            <a:ext cx="3355614" cy="148699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F3FEE-5F40-F248-B556-E00AA42CA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69908" y="934196"/>
            <a:ext cx="9872310" cy="148699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DF995-7FA5-864D-AF3F-7D6AB7AE2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AFD97-F89F-A042-BCAC-BC0C1F5BBEE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0DB7-A73C-F146-A650-8078BA459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75EA6-BF6F-744E-9873-479596026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3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6BCAB-63B0-0B40-A1CD-6F636AE3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3C1FF-5975-A24B-9612-9F4D8078E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  <a:lvl2pPr>
              <a:defRPr>
                <a:latin typeface="Helvetica" pitchFamily="2" charset="0"/>
              </a:defRPr>
            </a:lvl2pPr>
            <a:lvl3pPr>
              <a:defRPr>
                <a:latin typeface="Helvetica" pitchFamily="2" charset="0"/>
              </a:defRPr>
            </a:lvl3pPr>
            <a:lvl4pPr>
              <a:defRPr>
                <a:latin typeface="Helvetica" pitchFamily="2" charset="0"/>
              </a:defRPr>
            </a:lvl4pPr>
            <a:lvl5pPr>
              <a:defRPr>
                <a:latin typeface="Helvetica" pitchFamily="2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7CDC7-9740-B040-983D-33DDDDE7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340408B7-D42E-4C40-89A4-53776FE370D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FD91A-E71C-1D47-94FA-105097732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963D9-D362-084E-A363-1035C73F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5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06A6-B130-8646-91CA-51BA7094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1801" y="4374479"/>
            <a:ext cx="13422452" cy="7298912"/>
          </a:xfrm>
        </p:spPr>
        <p:txBody>
          <a:bodyPr anchor="b"/>
          <a:lstStyle>
            <a:lvl1pPr>
              <a:defRPr sz="701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7092-8299-0F4C-96A4-1F50B49D6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1801" y="11742440"/>
            <a:ext cx="13422452" cy="3838326"/>
          </a:xfrm>
        </p:spPr>
        <p:txBody>
          <a:bodyPr/>
          <a:lstStyle>
            <a:lvl1pPr marL="0" indent="0">
              <a:buNone/>
              <a:defRPr sz="2808">
                <a:solidFill>
                  <a:schemeClr val="tx1">
                    <a:tint val="75000"/>
                  </a:schemeClr>
                </a:solidFill>
              </a:defRPr>
            </a:lvl1pPr>
            <a:lvl2pPr marL="53480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601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44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92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40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88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36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84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234A5-3EA3-114F-9B8B-EB41ACD3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F1EB0-11AC-F446-8CA5-7341363638B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FDE48-88CC-6844-9818-67B67F5D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2AAED-26E7-0944-8097-920E2AE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8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E0AA4-ECB6-C649-A5FD-599CA1B4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37DD4-21E9-A04D-8AAA-6FF372C4F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69908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E2B60-9163-5C47-B9BE-BB764836C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878397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A7DC1-0841-544D-8B31-7BAE4AD41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080E-0CB5-2941-B48B-86F18F07B5FA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660F6-B518-6B45-868E-407C95D4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DDEB9-06EA-3740-BB27-3320884B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89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F03E9-9489-B344-96BA-70C2254D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2" y="934198"/>
            <a:ext cx="13422452" cy="33915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D0287-7AFF-A84D-916C-B7822B3E6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71933" y="4301366"/>
            <a:ext cx="6583566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586489-A7CB-EE4F-8D4A-9A4C48846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71933" y="6409396"/>
            <a:ext cx="6583566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F99574-E31E-EF42-916F-6A9CC901AE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878398" y="4301366"/>
            <a:ext cx="6615989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353DB1-1C23-404C-9DE8-78219D7C7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878398" y="6409396"/>
            <a:ext cx="6615989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1BB78-2A66-9D4F-BFBB-BB7E1C9A5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C91F-C901-C74E-B457-F7DD6456F136}" type="datetime1">
              <a:rPr lang="en-US" smtClean="0"/>
              <a:t>8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FFCAAF-9320-C347-9837-DA18EAECC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93220E-C952-9842-ADE8-3451593D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2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BD052-973D-994F-AF52-2A4EF5FBD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F58DD-8363-6A46-9A18-1A3A67A0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9D0AC-686B-8B49-B366-3C844C4036EB}" type="datetime1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8FEACB-F9AE-8C44-97F6-788024312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56A4EF-28C8-B843-B0C9-3D10255B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3EE6B9-1BFB-B447-ADE2-74BAB0E6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D6573-C21F-0840-BAEF-1FF2575D4505}" type="datetime1">
              <a:rPr lang="en-US" smtClean="0"/>
              <a:t>8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C450CF-5F7E-5045-8B0A-4C0434E6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94176-5BE4-AD43-A449-C8199EE33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9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1379-D019-6643-B88B-FB65AC5F9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8BD4D-DDCA-534A-8E83-F635DBDD4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>
              <a:defRPr sz="3743"/>
            </a:lvl1pPr>
            <a:lvl2pPr>
              <a:defRPr sz="3275"/>
            </a:lvl2pPr>
            <a:lvl3pPr>
              <a:defRPr sz="2808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42C9D0-AF82-204E-8201-19343DD61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368A2-7186-E749-BB60-CB45376A4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D7268-FD7C-C042-A400-6B8C34629FE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BA04-E120-A946-B561-D46CCA0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C79DB-2B92-7742-9F5E-538E7EE6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29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C82B-7C1B-8F43-8CBD-0D90B839A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15C3E0-9E53-C34D-8BE5-403FD64408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 marL="0" indent="0">
              <a:buNone/>
              <a:defRPr sz="3743"/>
            </a:lvl1pPr>
            <a:lvl2pPr marL="534800" indent="0">
              <a:buNone/>
              <a:defRPr sz="3275"/>
            </a:lvl2pPr>
            <a:lvl3pPr marL="1069601" indent="0">
              <a:buNone/>
              <a:defRPr sz="2808"/>
            </a:lvl3pPr>
            <a:lvl4pPr marL="1604400" indent="0">
              <a:buNone/>
              <a:defRPr sz="2339"/>
            </a:lvl4pPr>
            <a:lvl5pPr marL="2139200" indent="0">
              <a:buNone/>
              <a:defRPr sz="2339"/>
            </a:lvl5pPr>
            <a:lvl6pPr marL="2674001" indent="0">
              <a:buNone/>
              <a:defRPr sz="2339"/>
            </a:lvl6pPr>
            <a:lvl7pPr marL="3208801" indent="0">
              <a:buNone/>
              <a:defRPr sz="2339"/>
            </a:lvl7pPr>
            <a:lvl8pPr marL="3743601" indent="0">
              <a:buNone/>
              <a:defRPr sz="2339"/>
            </a:lvl8pPr>
            <a:lvl9pPr marL="4278401" indent="0">
              <a:buNone/>
              <a:defRPr sz="233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C6D1B-B939-084A-AA38-F2265164B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5EC78-0900-3A42-A704-5CF19E63C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9D5A2-F22A-5741-B25B-A3DF52EE188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E44BA-DA4D-FB45-BD8D-5126D010E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A10B7-6203-F24D-9E0C-733A6B0C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985200-F03E-DA4D-914D-EBD5272F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9906" y="934198"/>
            <a:ext cx="13422452" cy="2809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27D6C5-F073-1E46-B343-DB812445F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9906" y="3743282"/>
            <a:ext cx="13422452" cy="1207208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EB330-0B14-4A48-890E-1E18399472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69908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232FD189-7F13-AC44-ADD0-90F8923151E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21E18-00F1-0145-899C-ECF615AEA9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155000" y="16263137"/>
            <a:ext cx="5252264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FFE07-FCDD-3549-9A82-C340CF9F9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990849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7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1069601" rtl="0" eaLnBrk="1" latinLnBrk="0" hangingPunct="1">
        <a:lnSpc>
          <a:spcPct val="90000"/>
        </a:lnSpc>
        <a:spcBef>
          <a:spcPct val="0"/>
        </a:spcBef>
        <a:buNone/>
        <a:defRPr sz="3275" kern="1200">
          <a:solidFill>
            <a:schemeClr val="tx1"/>
          </a:solidFill>
          <a:latin typeface="Helvetica" pitchFamily="2" charset="0"/>
          <a:ea typeface="+mj-ea"/>
          <a:cs typeface="Arial" panose="020B0604020202020204" pitchFamily="34" charset="0"/>
        </a:defRPr>
      </a:lvl1pPr>
    </p:titleStyle>
    <p:bodyStyle>
      <a:lvl1pPr marL="267400" indent="-267400" algn="l" defTabSz="1069601" rtl="0" eaLnBrk="1" latinLnBrk="0" hangingPunct="1">
        <a:lnSpc>
          <a:spcPct val="90000"/>
        </a:lnSpc>
        <a:spcBef>
          <a:spcPts val="117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1pPr>
      <a:lvl2pPr marL="8022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2pPr>
      <a:lvl3pPr marL="13370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3pPr>
      <a:lvl4pPr marL="1871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4pPr>
      <a:lvl5pPr marL="24066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404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5pPr>
      <a:lvl6pPr marL="29414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62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110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5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8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44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92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40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88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3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84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tiff"/><Relationship Id="rId3" Type="http://schemas.openxmlformats.org/officeDocument/2006/relationships/image" Target="../media/image1.emf"/><Relationship Id="rId21" Type="http://schemas.openxmlformats.org/officeDocument/2006/relationships/image" Target="../media/image19.tif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10" Type="http://schemas.openxmlformats.org/officeDocument/2006/relationships/image" Target="../media/image8.emf"/><Relationship Id="rId19" Type="http://schemas.openxmlformats.org/officeDocument/2006/relationships/image" Target="../media/image17.tif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F74B3-D458-EBB5-9A47-4958F4FE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pPr/>
              <a:t>1</a:t>
            </a:fld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259A06-E51D-F074-9C21-F0C88B678F0F}"/>
              </a:ext>
            </a:extLst>
          </p:cNvPr>
          <p:cNvSpPr txBox="1"/>
          <p:nvPr/>
        </p:nvSpPr>
        <p:spPr>
          <a:xfrm>
            <a:off x="458875" y="14641346"/>
            <a:ext cx="1431827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. Flow cytometry analysis of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 derived CSCs.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vo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C marker analysis.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efly, mice were inoculated with CAOV4 cells and treated with either vehicle, carboplatin or carboplatin plus BLZ945. Mice were sacrificed at 3 days following 4 cycles of carboplatin or allowed to reach endpoint criteria. Tumors were disassociated and analyzed for cancer stem-like cell expression (CD177+CD133+ALDH+). A-B) Cancer stem-like cell expression of CD177+, CD133+, and ALDH+ (inset is DEAB) via flow cytometry in residual and regrown tumors. Representative gates of CSCs from regrown tumors (A) and quantification (B). Mean and SD. One-way ANOVA, Tukey post-hoc test. C-D) qPCR analysis of </a:t>
            </a:r>
            <a:r>
              <a:rPr lang="en-US" sz="1800" i="1" dirty="0">
                <a:latin typeface="Times New Roman"/>
                <a:ea typeface="Times New Roman"/>
                <a:cs typeface="Times New Roman"/>
                <a:sym typeface="Times New Roman"/>
              </a:rPr>
              <a:t>SOX2, OCT4</a:t>
            </a:r>
            <a:r>
              <a:rPr lang="en-US" sz="1800" dirty="0">
                <a:latin typeface="Times New Roman"/>
                <a:ea typeface="Times New Roman"/>
                <a:cs typeface="Times New Roman"/>
                <a:sym typeface="Times New Roman"/>
              </a:rPr>
              <a:t> and </a:t>
            </a:r>
            <a:r>
              <a:rPr lang="en-US" sz="1800" i="1" dirty="0">
                <a:latin typeface="Times New Roman"/>
                <a:ea typeface="Times New Roman"/>
                <a:cs typeface="Times New Roman"/>
                <a:sym typeface="Times New Roman"/>
              </a:rPr>
              <a:t>NANOG</a:t>
            </a:r>
            <a:r>
              <a:rPr lang="en-US" sz="1800" dirty="0">
                <a:latin typeface="Times New Roman"/>
                <a:ea typeface="Times New Roman"/>
                <a:cs typeface="Times New Roman"/>
                <a:sym typeface="Times New Roman"/>
              </a:rPr>
              <a:t> gene expression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AOV4 (C) and OVCAR8 (D) cells after 48 hours treatment with CCL2/MCP-1 (10 ng/mL), carboplatin (275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in combination relative to vehicle. One-way ANOVA, Tukey post-hoc test. Mean and SEM. *p&lt;0.05, no stars indicate ns.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9C94C01-6FB2-F691-C39E-F2FB8293BC6F}"/>
              </a:ext>
            </a:extLst>
          </p:cNvPr>
          <p:cNvSpPr txBox="1"/>
          <p:nvPr/>
        </p:nvSpPr>
        <p:spPr>
          <a:xfrm rot="10800000" flipH="1" flipV="1">
            <a:off x="22526" y="285271"/>
            <a:ext cx="897915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C5F78B84-761F-0BB0-45C2-77343F10ECC6}"/>
              </a:ext>
            </a:extLst>
          </p:cNvPr>
          <p:cNvGrpSpPr/>
          <p:nvPr/>
        </p:nvGrpSpPr>
        <p:grpSpPr>
          <a:xfrm>
            <a:off x="22525" y="6275052"/>
            <a:ext cx="14580009" cy="3964601"/>
            <a:chOff x="22525" y="6275052"/>
            <a:chExt cx="14580009" cy="3964601"/>
          </a:xfrm>
        </p:grpSpPr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D4679411-4E00-EC74-C871-CF5C3AB85C50}"/>
                </a:ext>
              </a:extLst>
            </p:cNvPr>
            <p:cNvGrpSpPr/>
            <p:nvPr/>
          </p:nvGrpSpPr>
          <p:grpSpPr>
            <a:xfrm>
              <a:off x="633488" y="6304435"/>
              <a:ext cx="13969046" cy="3935218"/>
              <a:chOff x="102080" y="6457334"/>
              <a:chExt cx="18122900" cy="5105400"/>
            </a:xfrm>
          </p:grpSpPr>
          <p:pic>
            <p:nvPicPr>
              <p:cNvPr id="157" name="Picture 156">
                <a:extLst>
                  <a:ext uri="{FF2B5EF4-FFF2-40B4-BE49-F238E27FC236}">
                    <a16:creationId xmlns:a16="http://schemas.microsoft.com/office/drawing/2014/main" id="{A7749B1F-8814-4776-F2D0-FD1AD71354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2080" y="6457334"/>
                <a:ext cx="6083300" cy="5105400"/>
              </a:xfrm>
              <a:prstGeom prst="rect">
                <a:avLst/>
              </a:prstGeom>
            </p:spPr>
          </p:pic>
          <p:pic>
            <p:nvPicPr>
              <p:cNvPr id="165" name="Picture 164">
                <a:extLst>
                  <a:ext uri="{FF2B5EF4-FFF2-40B4-BE49-F238E27FC236}">
                    <a16:creationId xmlns:a16="http://schemas.microsoft.com/office/drawing/2014/main" id="{435E851A-0BE0-DB00-5BF3-5EFDE646D6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2141680" y="6457334"/>
                <a:ext cx="6083300" cy="5105400"/>
              </a:xfrm>
              <a:prstGeom prst="rect">
                <a:avLst/>
              </a:prstGeom>
            </p:spPr>
          </p:pic>
          <p:pic>
            <p:nvPicPr>
              <p:cNvPr id="166" name="Picture 165">
                <a:extLst>
                  <a:ext uri="{FF2B5EF4-FFF2-40B4-BE49-F238E27FC236}">
                    <a16:creationId xmlns:a16="http://schemas.microsoft.com/office/drawing/2014/main" id="{A9FFEE0E-803D-63B5-CD48-8B1C4CD23A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121880" y="6457334"/>
                <a:ext cx="6083300" cy="5105400"/>
              </a:xfrm>
              <a:prstGeom prst="rect">
                <a:avLst/>
              </a:prstGeom>
            </p:spPr>
          </p:pic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4C34D4A-B068-2438-6359-43477C51968E}"/>
                </a:ext>
              </a:extLst>
            </p:cNvPr>
            <p:cNvSpPr txBox="1"/>
            <p:nvPr/>
          </p:nvSpPr>
          <p:spPr>
            <a:xfrm>
              <a:off x="22525" y="6275052"/>
              <a:ext cx="752413" cy="4001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370CFD76-3073-D1AE-45A2-8CD0824FFCC8}"/>
              </a:ext>
            </a:extLst>
          </p:cNvPr>
          <p:cNvGrpSpPr/>
          <p:nvPr/>
        </p:nvGrpSpPr>
        <p:grpSpPr>
          <a:xfrm>
            <a:off x="22525" y="10212561"/>
            <a:ext cx="14580009" cy="4138514"/>
            <a:chOff x="22525" y="10212561"/>
            <a:chExt cx="14580009" cy="4138514"/>
          </a:xfrm>
        </p:grpSpPr>
        <p:grpSp>
          <p:nvGrpSpPr>
            <p:cNvPr id="185" name="Group 184">
              <a:extLst>
                <a:ext uri="{FF2B5EF4-FFF2-40B4-BE49-F238E27FC236}">
                  <a16:creationId xmlns:a16="http://schemas.microsoft.com/office/drawing/2014/main" id="{D9C9491D-1823-E64F-BF27-56991D05682E}"/>
                </a:ext>
              </a:extLst>
            </p:cNvPr>
            <p:cNvGrpSpPr/>
            <p:nvPr/>
          </p:nvGrpSpPr>
          <p:grpSpPr>
            <a:xfrm>
              <a:off x="633488" y="10239653"/>
              <a:ext cx="13969046" cy="4111422"/>
              <a:chOff x="102080" y="10089089"/>
              <a:chExt cx="18122900" cy="5334000"/>
            </a:xfrm>
          </p:grpSpPr>
          <p:pic>
            <p:nvPicPr>
              <p:cNvPr id="177" name="Picture 176">
                <a:extLst>
                  <a:ext uri="{FF2B5EF4-FFF2-40B4-BE49-F238E27FC236}">
                    <a16:creationId xmlns:a16="http://schemas.microsoft.com/office/drawing/2014/main" id="{D0C1F1F4-2813-FEBC-5CBB-39100F75F8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2080" y="10089089"/>
                <a:ext cx="6083300" cy="5334000"/>
              </a:xfrm>
              <a:prstGeom prst="rect">
                <a:avLst/>
              </a:prstGeom>
            </p:spPr>
          </p:pic>
          <p:pic>
            <p:nvPicPr>
              <p:cNvPr id="179" name="Picture 178">
                <a:extLst>
                  <a:ext uri="{FF2B5EF4-FFF2-40B4-BE49-F238E27FC236}">
                    <a16:creationId xmlns:a16="http://schemas.microsoft.com/office/drawing/2014/main" id="{1E1C366A-8AA2-C089-AC88-4CEFD24498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121880" y="10317689"/>
                <a:ext cx="6083300" cy="5105400"/>
              </a:xfrm>
              <a:prstGeom prst="rect">
                <a:avLst/>
              </a:prstGeom>
            </p:spPr>
          </p:pic>
          <p:pic>
            <p:nvPicPr>
              <p:cNvPr id="182" name="Picture 181">
                <a:extLst>
                  <a:ext uri="{FF2B5EF4-FFF2-40B4-BE49-F238E27FC236}">
                    <a16:creationId xmlns:a16="http://schemas.microsoft.com/office/drawing/2014/main" id="{E92373EB-EF7F-941D-9F37-73572C9204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2141680" y="10317689"/>
                <a:ext cx="6083300" cy="5105400"/>
              </a:xfrm>
              <a:prstGeom prst="rect">
                <a:avLst/>
              </a:prstGeom>
            </p:spPr>
          </p:pic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DC6B97D-B1DA-050B-AF71-AE5895F13F02}"/>
                </a:ext>
              </a:extLst>
            </p:cNvPr>
            <p:cNvSpPr txBox="1"/>
            <p:nvPr/>
          </p:nvSpPr>
          <p:spPr>
            <a:xfrm>
              <a:off x="22525" y="10212561"/>
              <a:ext cx="752413" cy="4001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</a:p>
          </p:txBody>
        </p:sp>
      </p:grpSp>
      <p:sp>
        <p:nvSpPr>
          <p:cNvPr id="156" name="TextBox 155">
            <a:extLst>
              <a:ext uri="{FF2B5EF4-FFF2-40B4-BE49-F238E27FC236}">
                <a16:creationId xmlns:a16="http://schemas.microsoft.com/office/drawing/2014/main" id="{CD052AF6-4FEA-B801-8223-4A7D567EF8B2}"/>
              </a:ext>
            </a:extLst>
          </p:cNvPr>
          <p:cNvSpPr txBox="1"/>
          <p:nvPr/>
        </p:nvSpPr>
        <p:spPr>
          <a:xfrm rot="10800000" flipH="1" flipV="1">
            <a:off x="6052911" y="285272"/>
            <a:ext cx="897915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B9EC5D96-B266-2705-12D9-A5CB8D72F949}"/>
              </a:ext>
            </a:extLst>
          </p:cNvPr>
          <p:cNvGrpSpPr/>
          <p:nvPr/>
        </p:nvGrpSpPr>
        <p:grpSpPr>
          <a:xfrm>
            <a:off x="6164877" y="285271"/>
            <a:ext cx="9321878" cy="5779707"/>
            <a:chOff x="6047373" y="8756386"/>
            <a:chExt cx="9321878" cy="5779707"/>
          </a:xfrm>
        </p:grpSpPr>
        <p:pic>
          <p:nvPicPr>
            <p:cNvPr id="171" name="Picture 170">
              <a:extLst>
                <a:ext uri="{FF2B5EF4-FFF2-40B4-BE49-F238E27FC236}">
                  <a16:creationId xmlns:a16="http://schemas.microsoft.com/office/drawing/2014/main" id="{A53ECE56-9799-10E4-2969-9D4007154A0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047373" y="9065479"/>
              <a:ext cx="3094091" cy="2577291"/>
            </a:xfrm>
            <a:prstGeom prst="rect">
              <a:avLst/>
            </a:prstGeom>
          </p:spPr>
        </p:pic>
        <p:pic>
          <p:nvPicPr>
            <p:cNvPr id="172" name="Picture 171">
              <a:extLst>
                <a:ext uri="{FF2B5EF4-FFF2-40B4-BE49-F238E27FC236}">
                  <a16:creationId xmlns:a16="http://schemas.microsoft.com/office/drawing/2014/main" id="{54BE2FAB-9528-ACF2-C9E1-9D34075FC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9219952" y="9068083"/>
              <a:ext cx="3094092" cy="2577292"/>
            </a:xfrm>
            <a:prstGeom prst="rect">
              <a:avLst/>
            </a:prstGeom>
          </p:spPr>
        </p:pic>
        <p:pic>
          <p:nvPicPr>
            <p:cNvPr id="175" name="Picture 174">
              <a:extLst>
                <a:ext uri="{FF2B5EF4-FFF2-40B4-BE49-F238E27FC236}">
                  <a16:creationId xmlns:a16="http://schemas.microsoft.com/office/drawing/2014/main" id="{0A9EF49A-21DE-4D9A-B058-49577E3F3840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047373" y="11960991"/>
              <a:ext cx="3090672" cy="2575102"/>
            </a:xfrm>
            <a:prstGeom prst="rect">
              <a:avLst/>
            </a:prstGeom>
          </p:spPr>
        </p:pic>
        <p:pic>
          <p:nvPicPr>
            <p:cNvPr id="176" name="Picture 175">
              <a:extLst>
                <a:ext uri="{FF2B5EF4-FFF2-40B4-BE49-F238E27FC236}">
                  <a16:creationId xmlns:a16="http://schemas.microsoft.com/office/drawing/2014/main" id="{9EE617E2-7D56-4909-795C-1A111C9D0E38}"/>
                </a:ext>
              </a:extLst>
            </p:cNvPr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219952" y="11960991"/>
              <a:ext cx="3090672" cy="2575102"/>
            </a:xfrm>
            <a:prstGeom prst="rect">
              <a:avLst/>
            </a:prstGeom>
          </p:spPr>
        </p:pic>
        <p:pic>
          <p:nvPicPr>
            <p:cNvPr id="180" name="Picture 179">
              <a:extLst>
                <a:ext uri="{FF2B5EF4-FFF2-40B4-BE49-F238E27FC236}">
                  <a16:creationId xmlns:a16="http://schemas.microsoft.com/office/drawing/2014/main" id="{B8CF5D98-3227-9123-6399-35179863E993}"/>
                </a:ext>
              </a:extLst>
            </p:cNvPr>
            <p:cNvPicPr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2278579" y="9064162"/>
              <a:ext cx="3090672" cy="2578608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40312AD-0985-8EA7-5946-2AF47252AB30}"/>
                </a:ext>
              </a:extLst>
            </p:cNvPr>
            <p:cNvSpPr txBox="1"/>
            <p:nvPr/>
          </p:nvSpPr>
          <p:spPr>
            <a:xfrm>
              <a:off x="6434884" y="11649295"/>
              <a:ext cx="2366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ROWN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4838448-5F46-EB62-C6A2-9F85529A53D5}"/>
                </a:ext>
              </a:extLst>
            </p:cNvPr>
            <p:cNvSpPr txBox="1"/>
            <p:nvPr/>
          </p:nvSpPr>
          <p:spPr>
            <a:xfrm>
              <a:off x="9677691" y="11649295"/>
              <a:ext cx="2366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ROWN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8A74E80F-4266-8632-5AC5-3774C2285238}"/>
                </a:ext>
              </a:extLst>
            </p:cNvPr>
            <p:cNvSpPr txBox="1"/>
            <p:nvPr/>
          </p:nvSpPr>
          <p:spPr>
            <a:xfrm>
              <a:off x="12688978" y="11649295"/>
              <a:ext cx="2366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ROWN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328EFFA-60CC-DB80-4E7B-56586AE5E473}"/>
                </a:ext>
              </a:extLst>
            </p:cNvPr>
            <p:cNvSpPr txBox="1"/>
            <p:nvPr/>
          </p:nvSpPr>
          <p:spPr>
            <a:xfrm>
              <a:off x="6618111" y="8756386"/>
              <a:ext cx="2206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AL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E5933CD-D9EA-421E-51C2-3091681AADC6}"/>
                </a:ext>
              </a:extLst>
            </p:cNvPr>
            <p:cNvSpPr txBox="1"/>
            <p:nvPr/>
          </p:nvSpPr>
          <p:spPr>
            <a:xfrm>
              <a:off x="9797080" y="8756386"/>
              <a:ext cx="2206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AL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27255CE4-4879-CCBC-5ADA-59F302CDA70F}"/>
                </a:ext>
              </a:extLst>
            </p:cNvPr>
            <p:cNvSpPr txBox="1"/>
            <p:nvPr/>
          </p:nvSpPr>
          <p:spPr>
            <a:xfrm>
              <a:off x="12829487" y="8756386"/>
              <a:ext cx="2206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AL</a:t>
              </a:r>
            </a:p>
          </p:txBody>
        </p:sp>
        <p:pic>
          <p:nvPicPr>
            <p:cNvPr id="189" name="Picture 188">
              <a:extLst>
                <a:ext uri="{FF2B5EF4-FFF2-40B4-BE49-F238E27FC236}">
                  <a16:creationId xmlns:a16="http://schemas.microsoft.com/office/drawing/2014/main" id="{84B19F29-F66C-E39F-3268-CD0F03C519EC}"/>
                </a:ext>
              </a:extLst>
            </p:cNvPr>
            <p:cNvPicPr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2278579" y="11957485"/>
              <a:ext cx="3090672" cy="2578608"/>
            </a:xfrm>
            <a:prstGeom prst="rect">
              <a:avLst/>
            </a:prstGeom>
          </p:spPr>
        </p:pic>
      </p:grp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286CE021-C92B-CDBD-D89E-29BCDD3369C5}"/>
              </a:ext>
            </a:extLst>
          </p:cNvPr>
          <p:cNvGrpSpPr/>
          <p:nvPr/>
        </p:nvGrpSpPr>
        <p:grpSpPr>
          <a:xfrm>
            <a:off x="102080" y="411974"/>
            <a:ext cx="5923508" cy="5165564"/>
            <a:chOff x="-432196" y="9362910"/>
            <a:chExt cx="5923508" cy="5165564"/>
          </a:xfrm>
        </p:grpSpPr>
        <p:pic>
          <p:nvPicPr>
            <p:cNvPr id="193" name="Picture 192">
              <a:extLst>
                <a:ext uri="{FF2B5EF4-FFF2-40B4-BE49-F238E27FC236}">
                  <a16:creationId xmlns:a16="http://schemas.microsoft.com/office/drawing/2014/main" id="{EB1F9AE2-362A-939F-A2D6-7E858DEB4D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594478" y="9383082"/>
              <a:ext cx="1690913" cy="1615999"/>
            </a:xfrm>
            <a:prstGeom prst="rect">
              <a:avLst/>
            </a:prstGeom>
          </p:spPr>
        </p:pic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778E3E5F-ABC6-EE2C-B26F-F4B8347AE14B}"/>
                </a:ext>
              </a:extLst>
            </p:cNvPr>
            <p:cNvSpPr txBox="1"/>
            <p:nvPr/>
          </p:nvSpPr>
          <p:spPr>
            <a:xfrm>
              <a:off x="255956" y="10020152"/>
              <a:ext cx="8944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75C54D8E-8B5C-EE4C-8483-98A6227849B2}"/>
                </a:ext>
              </a:extLst>
            </p:cNvPr>
            <p:cNvSpPr txBox="1"/>
            <p:nvPr/>
          </p:nvSpPr>
          <p:spPr>
            <a:xfrm>
              <a:off x="-432196" y="11569131"/>
              <a:ext cx="13901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platin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F3B8F4E2-B97D-3CDB-85F1-522B090C000B}"/>
                </a:ext>
              </a:extLst>
            </p:cNvPr>
            <p:cNvSpPr txBox="1"/>
            <p:nvPr/>
          </p:nvSpPr>
          <p:spPr>
            <a:xfrm>
              <a:off x="-239692" y="12948965"/>
              <a:ext cx="139012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platin</a:t>
              </a:r>
            </a:p>
            <a:p>
              <a:pPr algn="ctr"/>
              <a:r>
                <a:rPr lang="en-US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BLZ945</a:t>
              </a:r>
            </a:p>
          </p:txBody>
        </p:sp>
        <p:pic>
          <p:nvPicPr>
            <p:cNvPr id="167" name="Picture 166">
              <a:extLst>
                <a:ext uri="{FF2B5EF4-FFF2-40B4-BE49-F238E27FC236}">
                  <a16:creationId xmlns:a16="http://schemas.microsoft.com/office/drawing/2014/main" id="{02DEFF0A-CCE2-F3B6-0779-45A300E36E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178306" y="9362910"/>
              <a:ext cx="1658807" cy="1615999"/>
            </a:xfrm>
            <a:prstGeom prst="rect">
              <a:avLst/>
            </a:prstGeom>
          </p:spPr>
        </p:pic>
        <p:pic>
          <p:nvPicPr>
            <p:cNvPr id="168" name="Picture 167">
              <a:extLst>
                <a:ext uri="{FF2B5EF4-FFF2-40B4-BE49-F238E27FC236}">
                  <a16:creationId xmlns:a16="http://schemas.microsoft.com/office/drawing/2014/main" id="{71837B69-2771-8D92-4BD3-52E431A37C64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170180" y="10879531"/>
              <a:ext cx="1686811" cy="1643281"/>
            </a:xfrm>
            <a:prstGeom prst="rect">
              <a:avLst/>
            </a:prstGeom>
          </p:spPr>
        </p:pic>
        <p:pic>
          <p:nvPicPr>
            <p:cNvPr id="169" name="Picture 168">
              <a:extLst>
                <a:ext uri="{FF2B5EF4-FFF2-40B4-BE49-F238E27FC236}">
                  <a16:creationId xmlns:a16="http://schemas.microsoft.com/office/drawing/2014/main" id="{B45E4010-6717-5313-89E2-7277EAAF819A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162583" y="12459710"/>
              <a:ext cx="1684373" cy="1640905"/>
            </a:xfrm>
            <a:prstGeom prst="rect">
              <a:avLst/>
            </a:prstGeom>
          </p:spPr>
        </p:pic>
        <p:grpSp>
          <p:nvGrpSpPr>
            <p:cNvPr id="178" name="Group 177">
              <a:extLst>
                <a:ext uri="{FF2B5EF4-FFF2-40B4-BE49-F238E27FC236}">
                  <a16:creationId xmlns:a16="http://schemas.microsoft.com/office/drawing/2014/main" id="{D0BEB600-33BB-B3E2-C3E0-6F2C32960837}"/>
                </a:ext>
              </a:extLst>
            </p:cNvPr>
            <p:cNvGrpSpPr/>
            <p:nvPr/>
          </p:nvGrpSpPr>
          <p:grpSpPr>
            <a:xfrm>
              <a:off x="1473171" y="13950263"/>
              <a:ext cx="1459050" cy="578211"/>
              <a:chOff x="2542664" y="12067079"/>
              <a:chExt cx="1459050" cy="578211"/>
            </a:xfrm>
          </p:grpSpPr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B0EC4DEF-24A9-71D3-E64C-AD6BE92A0B91}"/>
                  </a:ext>
                </a:extLst>
              </p:cNvPr>
              <p:cNvSpPr txBox="1"/>
              <p:nvPr/>
            </p:nvSpPr>
            <p:spPr>
              <a:xfrm>
                <a:off x="2700571" y="12275958"/>
                <a:ext cx="9830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17+</a:t>
                </a:r>
              </a:p>
            </p:txBody>
          </p:sp>
          <p:sp>
            <p:nvSpPr>
              <p:cNvPr id="3" name="Up Arrow 2">
                <a:extLst>
                  <a:ext uri="{FF2B5EF4-FFF2-40B4-BE49-F238E27FC236}">
                    <a16:creationId xmlns:a16="http://schemas.microsoft.com/office/drawing/2014/main" id="{D8A6C449-ADD7-1EC7-2FD4-3441EE35BB19}"/>
                  </a:ext>
                </a:extLst>
              </p:cNvPr>
              <p:cNvSpPr/>
              <p:nvPr/>
            </p:nvSpPr>
            <p:spPr>
              <a:xfrm rot="5400000">
                <a:off x="3156521" y="11453222"/>
                <a:ext cx="231335" cy="1459050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/>
              </a:p>
            </p:txBody>
          </p:sp>
        </p:grpSp>
        <p:grpSp>
          <p:nvGrpSpPr>
            <p:cNvPr id="173" name="Group 172">
              <a:extLst>
                <a:ext uri="{FF2B5EF4-FFF2-40B4-BE49-F238E27FC236}">
                  <a16:creationId xmlns:a16="http://schemas.microsoft.com/office/drawing/2014/main" id="{B5429980-9344-3E11-87F6-BAAB0E10535C}"/>
                </a:ext>
              </a:extLst>
            </p:cNvPr>
            <p:cNvGrpSpPr/>
            <p:nvPr/>
          </p:nvGrpSpPr>
          <p:grpSpPr>
            <a:xfrm>
              <a:off x="861279" y="9423756"/>
              <a:ext cx="436315" cy="4437887"/>
              <a:chOff x="1930772" y="7506066"/>
              <a:chExt cx="436315" cy="4437887"/>
            </a:xfrm>
          </p:grpSpPr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5083E92D-BF72-9AF3-9816-23BCAFBB43A6}"/>
                  </a:ext>
                </a:extLst>
              </p:cNvPr>
              <p:cNvSpPr txBox="1"/>
              <p:nvPr/>
            </p:nvSpPr>
            <p:spPr>
              <a:xfrm rot="16200000">
                <a:off x="1617545" y="9585972"/>
                <a:ext cx="99578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33+</a:t>
                </a:r>
              </a:p>
            </p:txBody>
          </p:sp>
          <p:sp>
            <p:nvSpPr>
              <p:cNvPr id="43" name="Up Arrow 42">
                <a:extLst>
                  <a:ext uri="{FF2B5EF4-FFF2-40B4-BE49-F238E27FC236}">
                    <a16:creationId xmlns:a16="http://schemas.microsoft.com/office/drawing/2014/main" id="{2FFF7D98-4C71-E7DD-AFD6-E594C6DF1E2B}"/>
                  </a:ext>
                </a:extLst>
              </p:cNvPr>
              <p:cNvSpPr/>
              <p:nvPr/>
            </p:nvSpPr>
            <p:spPr>
              <a:xfrm>
                <a:off x="2163074" y="7506066"/>
                <a:ext cx="204013" cy="4437887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 dirty="0"/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846C3E00-2634-B23A-CECB-71C3B45393D7}"/>
                </a:ext>
              </a:extLst>
            </p:cNvPr>
            <p:cNvGrpSpPr/>
            <p:nvPr/>
          </p:nvGrpSpPr>
          <p:grpSpPr>
            <a:xfrm>
              <a:off x="2980366" y="9408754"/>
              <a:ext cx="436315" cy="4437887"/>
              <a:chOff x="1930772" y="7506066"/>
              <a:chExt cx="436315" cy="4437887"/>
            </a:xfrm>
          </p:grpSpPr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6478F88A-7981-C27E-F82B-2FFD9413DFAF}"/>
                  </a:ext>
                </a:extLst>
              </p:cNvPr>
              <p:cNvSpPr txBox="1"/>
              <p:nvPr/>
            </p:nvSpPr>
            <p:spPr>
              <a:xfrm rot="16200000">
                <a:off x="1689680" y="9585972"/>
                <a:ext cx="85151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</a:p>
            </p:txBody>
          </p:sp>
          <p:sp>
            <p:nvSpPr>
              <p:cNvPr id="161" name="Up Arrow 160">
                <a:extLst>
                  <a:ext uri="{FF2B5EF4-FFF2-40B4-BE49-F238E27FC236}">
                    <a16:creationId xmlns:a16="http://schemas.microsoft.com/office/drawing/2014/main" id="{5CFF1F6B-48F6-886D-D856-D52E20CCED3F}"/>
                  </a:ext>
                </a:extLst>
              </p:cNvPr>
              <p:cNvSpPr/>
              <p:nvPr/>
            </p:nvSpPr>
            <p:spPr>
              <a:xfrm>
                <a:off x="2163074" y="7506066"/>
                <a:ext cx="204013" cy="4437887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 dirty="0"/>
              </a:p>
            </p:txBody>
          </p:sp>
        </p:grpSp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40EF5646-B1C0-BE7A-3D19-532AC504F462}"/>
                </a:ext>
              </a:extLst>
            </p:cNvPr>
            <p:cNvGrpSpPr/>
            <p:nvPr/>
          </p:nvGrpSpPr>
          <p:grpSpPr>
            <a:xfrm>
              <a:off x="3414789" y="13933408"/>
              <a:ext cx="2076523" cy="546481"/>
              <a:chOff x="2542663" y="12067080"/>
              <a:chExt cx="2076523" cy="546481"/>
            </a:xfrm>
          </p:grpSpPr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78088274-8962-BA6E-2B12-94BAB377FDB0}"/>
                  </a:ext>
                </a:extLst>
              </p:cNvPr>
              <p:cNvSpPr txBox="1"/>
              <p:nvPr/>
            </p:nvSpPr>
            <p:spPr>
              <a:xfrm>
                <a:off x="3141859" y="12244229"/>
                <a:ext cx="10406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DH+ </a:t>
                </a:r>
              </a:p>
            </p:txBody>
          </p:sp>
          <p:sp>
            <p:nvSpPr>
              <p:cNvPr id="187" name="Up Arrow 186">
                <a:extLst>
                  <a:ext uri="{FF2B5EF4-FFF2-40B4-BE49-F238E27FC236}">
                    <a16:creationId xmlns:a16="http://schemas.microsoft.com/office/drawing/2014/main" id="{426155AF-6DAB-0E20-4DE2-A57BEDB171BD}"/>
                  </a:ext>
                </a:extLst>
              </p:cNvPr>
              <p:cNvSpPr/>
              <p:nvPr/>
            </p:nvSpPr>
            <p:spPr>
              <a:xfrm rot="5400000">
                <a:off x="3465256" y="11144487"/>
                <a:ext cx="231338" cy="2076523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/>
              </a:p>
            </p:txBody>
          </p:sp>
        </p:grpSp>
        <p:pic>
          <p:nvPicPr>
            <p:cNvPr id="191" name="Picture 190">
              <a:extLst>
                <a:ext uri="{FF2B5EF4-FFF2-40B4-BE49-F238E27FC236}">
                  <a16:creationId xmlns:a16="http://schemas.microsoft.com/office/drawing/2014/main" id="{CB13DE76-F27C-9032-E78D-4D6F1085CE6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594478" y="12460359"/>
              <a:ext cx="1690913" cy="1615999"/>
            </a:xfrm>
            <a:prstGeom prst="rect">
              <a:avLst/>
            </a:prstGeom>
          </p:spPr>
        </p:pic>
        <p:pic>
          <p:nvPicPr>
            <p:cNvPr id="194" name="Picture 193">
              <a:extLst>
                <a:ext uri="{FF2B5EF4-FFF2-40B4-BE49-F238E27FC236}">
                  <a16:creationId xmlns:a16="http://schemas.microsoft.com/office/drawing/2014/main" id="{79C26102-AA2F-B93C-50BF-543C21B967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298410" y="12644042"/>
              <a:ext cx="904023" cy="863971"/>
            </a:xfrm>
            <a:prstGeom prst="rect">
              <a:avLst/>
            </a:prstGeom>
          </p:spPr>
        </p:pic>
        <p:pic>
          <p:nvPicPr>
            <p:cNvPr id="195" name="Picture 194">
              <a:extLst>
                <a:ext uri="{FF2B5EF4-FFF2-40B4-BE49-F238E27FC236}">
                  <a16:creationId xmlns:a16="http://schemas.microsoft.com/office/drawing/2014/main" id="{B9E597AE-6D8F-DEF7-8EC3-924BFCCE80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310474" y="9608785"/>
              <a:ext cx="892263" cy="852733"/>
            </a:xfrm>
            <a:prstGeom prst="rect">
              <a:avLst/>
            </a:prstGeom>
          </p:spPr>
        </p:pic>
        <p:pic>
          <p:nvPicPr>
            <p:cNvPr id="198" name="Picture 197">
              <a:extLst>
                <a:ext uri="{FF2B5EF4-FFF2-40B4-BE49-F238E27FC236}">
                  <a16:creationId xmlns:a16="http://schemas.microsoft.com/office/drawing/2014/main" id="{EB7A3A39-140A-4B1D-4434-78E6A5F191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/>
            <a:srcRect b="5907"/>
            <a:stretch/>
          </p:blipFill>
          <p:spPr>
            <a:xfrm>
              <a:off x="3591237" y="10913436"/>
              <a:ext cx="1694154" cy="1523458"/>
            </a:xfrm>
            <a:prstGeom prst="rect">
              <a:avLst/>
            </a:prstGeom>
          </p:spPr>
        </p:pic>
        <p:pic>
          <p:nvPicPr>
            <p:cNvPr id="197" name="Picture 196">
              <a:extLst>
                <a:ext uri="{FF2B5EF4-FFF2-40B4-BE49-F238E27FC236}">
                  <a16:creationId xmlns:a16="http://schemas.microsoft.com/office/drawing/2014/main" id="{64FEE148-A5D2-0CC2-07C4-56CE5D871B61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3293417" y="11104684"/>
              <a:ext cx="909016" cy="86874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27955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600" dirty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DenayLuis_Paper layout V1" id="{E285C894-8600-BE43-9C63-6DC2C64A29EE}" vid="{C2BEA0BC-9915-6141-982A-C72D398425B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23</TotalTime>
  <Words>226</Words>
  <Application>Microsoft Macintosh PowerPoint</Application>
  <PresentationFormat>Custom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SAs of polarized macrophage supernatants: TNF-α and IL-1β (M1)</dc:title>
  <dc:creator>Microsoft Office User</dc:creator>
  <cp:lastModifiedBy>Carrie House</cp:lastModifiedBy>
  <cp:revision>80</cp:revision>
  <dcterms:created xsi:type="dcterms:W3CDTF">2022-01-18T04:14:07Z</dcterms:created>
  <dcterms:modified xsi:type="dcterms:W3CDTF">2024-08-20T23:34:28Z</dcterms:modified>
</cp:coreProperties>
</file>